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153E8B4-8B03-4C62-84FF-FABA28DD1B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DE28494-D9D6-4660-9179-882494D2F2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33393C-3BB5-4200-9D08-3729E898A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02C73A5-5EA8-468A-AB31-C9DB4F009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049F14-CF73-40EC-97EA-994C11662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9656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F23772-49CE-406F-B2EB-208FEE603A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98100B5-1BB1-4B71-87AE-EE6C6D6E19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A1860B5-87FB-4D77-A43D-C23D1F2BA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A0DC203-2D81-4ABD-B4F7-CCCDBB251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1F90810-EAB2-40A5-A088-1022A12B6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7487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4EC7253-72FB-492D-ABCD-5255C1AA2C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16B835E-67B8-4D17-93A7-D476D115DA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595713D-9F77-4E7A-82E0-469CD2CAF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8637C37-6D89-4C32-9C88-A95C7F65E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647F619-981D-4534-AB5F-07662CE54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9610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8E6BC07-98AF-4F78-8EDA-A21D8520FC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BBBD68A-671D-4F32-A3EB-4F479F2F78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42D13F6-868C-4699-83F1-9CC86FB5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7B7CD8-C7DA-4B4B-8AAD-27E541C12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498B7C6-589F-4D40-B143-5BE8777C6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0663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B9C31F-D848-4DAA-AD10-59727DC5F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E6F08AA-4A68-4EA4-AEAA-15041461DC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77B899F-EC38-448E-A281-3F1C177F2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2F6E68D-8227-4275-9BC1-82DF410DA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173D6AF-F31A-4910-B788-F61D823CB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81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606BFE-E1A9-40D7-AB0C-B6A3D3C5F7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12001EB-3C57-4060-8C8B-179A6A9741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9409444-542E-4A37-9705-69F44E68BC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F65CB70-F9B1-45D8-AE27-F59932A2B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7F9161A-96E4-421D-AD27-13EC1CC57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380D68E-FC96-4EAB-88FB-0FBB36E28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5130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4D4F1C-D2A9-4C18-A236-EFA2B6957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B3E04B0-0D11-426F-A023-1D83099C06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BDD82F8-45ED-4DBD-9510-7DF74FC6D2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503BA60-7ED2-4438-A991-CA10D060A4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D8E1063-B7B0-48FE-882A-AD83BDB735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086D8EC-5FA2-46FD-8115-2323CB454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05B745D-542D-4D0D-855D-51A251761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63E9B9E-A5CC-47E3-BC4D-309D03238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4602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CDEC10-9800-4B15-85EB-CD104D77F6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00DD4BA-F8AD-4DAB-9D62-1C443505B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60D7D81-4E49-4329-B60D-901B4240B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A430870-F9F3-4EA8-B8A4-BE1B46068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321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36CD7AC-0C74-49B9-B400-83A07561D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B38B5B36-3E87-4AE5-8C30-77AAF1B97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499F523-F892-4686-8105-BD4006A47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4449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FE7BB3-BFB8-42B8-9C93-EA2FAD801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E9F8AC5-8EE8-430F-B992-ED34E519F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D7B8ACE-267B-4ECE-9643-71FD0F74FD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050B55F-08CA-4716-9872-DE9C67BC7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F8D3A2E-3E8F-403A-A98C-D18D158A9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0CCD3CA-4F03-4DA0-A72E-FF4055C62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874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411F956-862D-4FDB-90D5-7E1F093399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8155B17-EA23-4554-946F-F5E50E4B95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3D1C81A-4E96-48E6-9B0F-4963AF73A0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E0B5EED-EC15-4972-AE9E-E5EA8CEA1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974FC09-9BE1-448C-A96A-7F090C73B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46EC9DF-09D4-475D-8672-328E25C1D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6892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8792BEE-F38F-4076-811D-80E9E546EE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6C2BE48-4BF4-4727-A3B5-C1C0899FB4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E2947D7-1C23-430D-83C4-4DE1548C60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5AEA3-ECD2-43D8-9284-C49FA595B4AC}" type="datetimeFigureOut">
              <a:rPr lang="es-ES" smtClean="0"/>
              <a:t>16/10/2019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DEF00AB-C3A6-45DD-B193-84716E34BF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C2E9D0F-48A9-45A5-9D14-8A419A5491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111E5-21AD-4E13-833C-D53A757FE1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0632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1919536" y="1334187"/>
            <a:ext cx="19442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FLN</a:t>
            </a:r>
            <a:endParaRPr lang="es-ES" sz="1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101"/>
          <a:stretch/>
        </p:blipFill>
        <p:spPr bwMode="auto">
          <a:xfrm>
            <a:off x="1813553" y="1641964"/>
            <a:ext cx="2236306" cy="1087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631"/>
          <a:stretch/>
        </p:blipFill>
        <p:spPr bwMode="auto">
          <a:xfrm>
            <a:off x="1813553" y="2650075"/>
            <a:ext cx="2236306" cy="10798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170"/>
          <a:stretch/>
        </p:blipFill>
        <p:spPr bwMode="auto">
          <a:xfrm>
            <a:off x="1813553" y="3658187"/>
            <a:ext cx="2236306" cy="10866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6 CuadroTexto"/>
          <p:cNvSpPr txBox="1"/>
          <p:nvPr/>
        </p:nvSpPr>
        <p:spPr>
          <a:xfrm>
            <a:off x="1594500" y="2031905"/>
            <a:ext cx="495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T1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1594500" y="3036117"/>
            <a:ext cx="495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T2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1594500" y="4047622"/>
            <a:ext cx="495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T3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4078256" y="1334187"/>
            <a:ext cx="1945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FRN</a:t>
            </a:r>
            <a:endParaRPr lang="es-ES" sz="1400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076"/>
          <a:stretch/>
        </p:blipFill>
        <p:spPr bwMode="auto">
          <a:xfrm>
            <a:off x="4003710" y="1641964"/>
            <a:ext cx="2236306" cy="1088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690"/>
          <a:stretch/>
        </p:blipFill>
        <p:spPr bwMode="auto">
          <a:xfrm>
            <a:off x="4003710" y="2650075"/>
            <a:ext cx="2236306" cy="10642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930"/>
          <a:stretch/>
        </p:blipFill>
        <p:spPr bwMode="auto">
          <a:xfrm>
            <a:off x="4003710" y="3658188"/>
            <a:ext cx="2236306" cy="1075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293"/>
          <a:stretch/>
        </p:blipFill>
        <p:spPr bwMode="auto">
          <a:xfrm>
            <a:off x="6168000" y="1597244"/>
            <a:ext cx="2236306" cy="1114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956"/>
          <a:stretch/>
        </p:blipFill>
        <p:spPr bwMode="auto">
          <a:xfrm>
            <a:off x="6168000" y="2641244"/>
            <a:ext cx="2236306" cy="10603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269"/>
          <a:stretch/>
        </p:blipFill>
        <p:spPr bwMode="auto">
          <a:xfrm>
            <a:off x="6168000" y="3649243"/>
            <a:ext cx="2236306" cy="10851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16 CuadroTexto"/>
          <p:cNvSpPr txBox="1"/>
          <p:nvPr/>
        </p:nvSpPr>
        <p:spPr>
          <a:xfrm>
            <a:off x="6312024" y="1334187"/>
            <a:ext cx="2016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 smtClean="0"/>
              <a:t>FRS</a:t>
            </a:r>
            <a:endParaRPr lang="es-ES" sz="1400" b="1" dirty="0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D8196F11-7AD5-4266-84F2-44E36CDDEC47}"/>
              </a:ext>
            </a:extLst>
          </p:cNvPr>
          <p:cNvSpPr txBox="1"/>
          <p:nvPr/>
        </p:nvSpPr>
        <p:spPr>
          <a:xfrm>
            <a:off x="769680" y="4986396"/>
            <a:ext cx="1068644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 </a:t>
            </a:r>
            <a:r>
              <a:rPr lang="es-ES" b="1" dirty="0" smtClean="0"/>
              <a:t>Figure </a:t>
            </a:r>
            <a:r>
              <a:rPr lang="es-ES" b="1" dirty="0" smtClean="0"/>
              <a:t>S1</a:t>
            </a:r>
            <a:r>
              <a:rPr lang="es-ES" dirty="0" smtClean="0"/>
              <a:t>. </a:t>
            </a:r>
            <a:r>
              <a:rPr lang="en-US" b="1" dirty="0"/>
              <a:t>Histograms depicting the distribution of reproductive traits in </a:t>
            </a:r>
            <a:r>
              <a:rPr lang="en-US" b="1" dirty="0" smtClean="0"/>
              <a:t>among ILs population in 2016 experiment.</a:t>
            </a:r>
            <a:r>
              <a:rPr lang="en-US" dirty="0" smtClean="0"/>
              <a:t>  </a:t>
            </a:r>
            <a:r>
              <a:rPr lang="en-US" dirty="0"/>
              <a:t>Reproductive traits </a:t>
            </a:r>
            <a:r>
              <a:rPr lang="en-US" dirty="0" smtClean="0"/>
              <a:t>are flower </a:t>
            </a:r>
            <a:r>
              <a:rPr lang="en-US" dirty="0"/>
              <a:t>number (FLN), number of fruits per </a:t>
            </a:r>
            <a:r>
              <a:rPr lang="en-US" dirty="0" err="1"/>
              <a:t>inflorescense</a:t>
            </a:r>
            <a:r>
              <a:rPr lang="en-US" dirty="0"/>
              <a:t> (FRN) and percentage of fruit set (FRS</a:t>
            </a:r>
            <a:r>
              <a:rPr lang="en-US" dirty="0" smtClean="0"/>
              <a:t>), studied </a:t>
            </a:r>
            <a:r>
              <a:rPr lang="en-US" dirty="0"/>
              <a:t>in </a:t>
            </a:r>
            <a:r>
              <a:rPr lang="en-US" dirty="0" smtClean="0"/>
              <a:t>2016 at </a:t>
            </a:r>
            <a:r>
              <a:rPr lang="en-US" dirty="0"/>
              <a:t>three temperature regimens (T1: 25ºC day/20ºC night; T2: 30ºC day/25ºC night; T3: 35ºC day/30ºC night). Means of </a:t>
            </a:r>
            <a:r>
              <a:rPr lang="en-US" dirty="0" smtClean="0"/>
              <a:t>the </a:t>
            </a:r>
            <a:r>
              <a:rPr lang="en-US" dirty="0"/>
              <a:t>parents “Moneymaker” (MM) and TO-937 (TO) are indicated with </a:t>
            </a:r>
            <a:r>
              <a:rPr lang="en-US" dirty="0" smtClean="0"/>
              <a:t>arrows</a:t>
            </a:r>
            <a:endParaRPr lang="es-ES" dirty="0"/>
          </a:p>
        </p:txBody>
      </p:sp>
      <p:cxnSp>
        <p:nvCxnSpPr>
          <p:cNvPr id="19" name="Conector recto de flecha 18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>
            <a:off x="2772584" y="1690328"/>
            <a:ext cx="216024" cy="1049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de flecha 19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 rot="10800000" flipV="1">
            <a:off x="3533003" y="2211037"/>
            <a:ext cx="233621" cy="720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2468624" y="1598400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3609177" y="1976442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23" name="Conector recto de flecha 22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>
            <a:off x="5017386" y="1878997"/>
            <a:ext cx="216024" cy="1049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uadroTexto 24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4674701" y="1692979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>
            <a:off x="7465443" y="1724704"/>
            <a:ext cx="216024" cy="1049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de flecha 27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 rot="10800000" flipV="1">
            <a:off x="7984892" y="1741430"/>
            <a:ext cx="233621" cy="720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uadroTexto 28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7161483" y="1632776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8206804" y="1567217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>
            <a:off x="5935862" y="2237020"/>
            <a:ext cx="145272" cy="1922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uadroTexto 38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5722992" y="1939755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43" name="Conector recto de flecha 42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 flipH="1">
            <a:off x="6398558" y="2657512"/>
            <a:ext cx="221795" cy="1321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de flecha 43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 flipH="1">
            <a:off x="6306551" y="2945241"/>
            <a:ext cx="215756" cy="1206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6576687" y="2543850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6475441" y="2755278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47" name="Conector recto de flecha 46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 flipH="1">
            <a:off x="4346085" y="3994833"/>
            <a:ext cx="78346" cy="2937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cto de flecha 47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  <a:stCxn id="50" idx="2"/>
          </p:cNvCxnSpPr>
          <p:nvPr/>
        </p:nvCxnSpPr>
        <p:spPr>
          <a:xfrm flipH="1">
            <a:off x="4138037" y="3840025"/>
            <a:ext cx="111916" cy="186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uadroTexto 48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4208407" y="3741413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4056501" y="3593804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51" name="Conector recto de flecha 50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>
            <a:off x="2790649" y="4234249"/>
            <a:ext cx="42702" cy="2480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de flecha 51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 flipH="1">
            <a:off x="1972101" y="3947180"/>
            <a:ext cx="75074" cy="3919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uadroTexto 52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2617987" y="4047622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1880084" y="3759301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55" name="Conector recto de flecha 54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 flipH="1">
            <a:off x="3051086" y="2920910"/>
            <a:ext cx="182301" cy="1563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uadroTexto 55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3167144" y="2729623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cxnSp>
        <p:nvCxnSpPr>
          <p:cNvPr id="58" name="Conector recto de flecha 57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>
            <a:off x="2666957" y="2891342"/>
            <a:ext cx="105627" cy="1821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uadroTexto 58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2366544" y="2680661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71" name="Conector recto de flecha 70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 flipH="1">
            <a:off x="4222336" y="2736894"/>
            <a:ext cx="221795" cy="1321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ector recto de flecha 71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 flipH="1">
            <a:off x="4130329" y="3024623"/>
            <a:ext cx="215756" cy="1206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CuadroTexto 72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4400465" y="2623232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4299219" y="2834660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  <p:cxnSp>
        <p:nvCxnSpPr>
          <p:cNvPr id="77" name="Conector recto de flecha 76">
            <a:extLst>
              <a:ext uri="{FF2B5EF4-FFF2-40B4-BE49-F238E27FC236}">
                <a16:creationId xmlns:a16="http://schemas.microsoft.com/office/drawing/2014/main" id="{950FDF6A-442F-4A36-AED8-FD6C9842B7E0}"/>
              </a:ext>
            </a:extLst>
          </p:cNvPr>
          <p:cNvCxnSpPr/>
          <p:nvPr/>
        </p:nvCxnSpPr>
        <p:spPr>
          <a:xfrm>
            <a:off x="6615891" y="4211904"/>
            <a:ext cx="4462" cy="2703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ector recto de flecha 77">
            <a:extLst>
              <a:ext uri="{FF2B5EF4-FFF2-40B4-BE49-F238E27FC236}">
                <a16:creationId xmlns:a16="http://schemas.microsoft.com/office/drawing/2014/main" id="{9EC1B9CF-15BF-4CDF-AD11-FAB465097849}"/>
              </a:ext>
            </a:extLst>
          </p:cNvPr>
          <p:cNvCxnSpPr>
            <a:cxnSpLocks/>
          </p:cNvCxnSpPr>
          <p:nvPr/>
        </p:nvCxnSpPr>
        <p:spPr>
          <a:xfrm rot="10800000" flipV="1">
            <a:off x="6414429" y="3727409"/>
            <a:ext cx="233621" cy="720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CuadroTexto 78">
            <a:extLst>
              <a:ext uri="{FF2B5EF4-FFF2-40B4-BE49-F238E27FC236}">
                <a16:creationId xmlns:a16="http://schemas.microsoft.com/office/drawing/2014/main" id="{1755018F-E3BE-4284-A365-80607BA062E8}"/>
              </a:ext>
            </a:extLst>
          </p:cNvPr>
          <p:cNvSpPr txBox="1"/>
          <p:nvPr/>
        </p:nvSpPr>
        <p:spPr>
          <a:xfrm>
            <a:off x="6430296" y="4040982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MM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A1ADC34F-CA66-49CE-BDD6-4D9BCD452B63}"/>
              </a:ext>
            </a:extLst>
          </p:cNvPr>
          <p:cNvSpPr txBox="1"/>
          <p:nvPr/>
        </p:nvSpPr>
        <p:spPr>
          <a:xfrm>
            <a:off x="6599259" y="3634652"/>
            <a:ext cx="386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Cambria" panose="02040503050406030204" pitchFamily="18" charset="0"/>
                <a:ea typeface="Cambria" panose="02040503050406030204" pitchFamily="18" charset="0"/>
              </a:rPr>
              <a:t>TO</a:t>
            </a:r>
          </a:p>
        </p:txBody>
      </p:sp>
    </p:spTree>
    <p:extLst>
      <p:ext uri="{BB962C8B-B14F-4D97-AF65-F5344CB8AC3E}">
        <p14:creationId xmlns:p14="http://schemas.microsoft.com/office/powerpoint/2010/main" val="1718902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5</TotalTime>
  <Words>112</Words>
  <Application>Microsoft Office PowerPoint</Application>
  <PresentationFormat>Panorámica</PresentationFormat>
  <Paragraphs>2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jose Gonzalo</dc:creator>
  <cp:lastModifiedBy>Antonio Monforte</cp:lastModifiedBy>
  <cp:revision>18</cp:revision>
  <dcterms:created xsi:type="dcterms:W3CDTF">2019-10-11T10:30:35Z</dcterms:created>
  <dcterms:modified xsi:type="dcterms:W3CDTF">2019-10-16T16:05:57Z</dcterms:modified>
</cp:coreProperties>
</file>